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62" r:id="rId7"/>
    <p:sldId id="27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4" r:id="rId18"/>
    <p:sldId id="275" r:id="rId19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00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5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5/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5/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5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5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5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E:\我的文件\程序作品\matlab\关联分析\700k\Alqq1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27584" y="404664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E:\我的文件\程序作品\matlab\关联分析\700k\Alqq4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99592" y="404664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E:\我的文件\程序作品\matlab\关联分析\700k\Alqq5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14400" y="685800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E:\我的文件\程序作品\matlab\关联分析\700k\Alqq6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99592" y="404664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 descr="E:\我的文件\程序作品\matlab\关联分析\700k\Alqq1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67544" y="404664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 descr="E:\我的文件\程序作品\matlab\关联分析\700k\Alqq2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14400" y="685800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 descr="E:\我的文件\程序作品\matlab\关联分析\700k\Alqq3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14400" y="685800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 descr="E:\我的文件\程序作品\matlab\关联分析\700k\Alqq4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14400" y="685800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 descr="E:\我的文件\程序作品\matlab\关联分析\700k\Alqq5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11560" y="404664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 descr="E:\我的文件\程序作品\matlab\关联分析\700k\Alqq6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55576" y="404664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E:\我的文件\程序作品\matlab\关联分析\700k\Alqq2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27584" y="404664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E:\我的文件\程序作品\matlab\关联分析\700k\Alqq3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83568" y="332656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E:\我的文件\程序作品\matlab\关联分析\700k\Alqq4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14400" y="685800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3" name="Picture 3" descr="E:\我的文件\程序作品\matlab\关联分析\700k\Alqq5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14400" y="685800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 descr="E:\我的文件\程序作品\matlab\关联分析\700k\Alqq6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14400" y="685800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我的文件\程序作品\matlab\关联分析\700k\Alqq1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99592" y="404664"/>
            <a:ext cx="7200800" cy="54006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我的文件\程序作品\matlab\关联分析\700k\Alqq2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14400" y="685800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E:\我的文件\程序作品\matlab\关联分析\700k\Alqq3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14400" y="685800"/>
            <a:ext cx="7315200" cy="54864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0</Words>
  <Application>Microsoft Office PowerPoint</Application>
  <PresentationFormat>全屏显示(4:3)</PresentationFormat>
  <Paragraphs>0</Paragraphs>
  <Slides>18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8</vt:i4>
      </vt:variant>
    </vt:vector>
  </HeadingPairs>
  <TitlesOfParts>
    <vt:vector size="19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  <vt:lpstr>幻灯片 8</vt:lpstr>
      <vt:lpstr>幻灯片 9</vt:lpstr>
      <vt:lpstr>幻灯片 10</vt:lpstr>
      <vt:lpstr>幻灯片 11</vt:lpstr>
      <vt:lpstr>幻灯片 12</vt:lpstr>
      <vt:lpstr>幻灯片 13</vt:lpstr>
      <vt:lpstr>幻灯片 14</vt:lpstr>
      <vt:lpstr>幻灯片 15</vt:lpstr>
      <vt:lpstr>幻灯片 16</vt:lpstr>
      <vt:lpstr>幻灯片 17</vt:lpstr>
      <vt:lpstr>幻灯片 18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ianxiang</dc:creator>
  <cp:lastModifiedBy>Administrator</cp:lastModifiedBy>
  <cp:revision>2</cp:revision>
  <dcterms:created xsi:type="dcterms:W3CDTF">2018-05-16T09:27:10Z</dcterms:created>
  <dcterms:modified xsi:type="dcterms:W3CDTF">2018-05-16T09:46:04Z</dcterms:modified>
</cp:coreProperties>
</file>